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7" r:id="rId2"/>
  </p:sldIdLst>
  <p:sldSz cx="9144000" cy="6858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929"/>
    <a:srgbClr val="003A17"/>
    <a:srgbClr val="FF3F3F"/>
    <a:srgbClr val="E60000"/>
    <a:srgbClr val="7F7F7F"/>
    <a:srgbClr val="FF7979"/>
    <a:srgbClr val="F9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51" autoAdjust="0"/>
  </p:normalViewPr>
  <p:slideViewPr>
    <p:cSldViewPr snapToGrid="0">
      <p:cViewPr varScale="1">
        <p:scale>
          <a:sx n="87" d="100"/>
          <a:sy n="87" d="100"/>
        </p:scale>
        <p:origin x="10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3414BF-809F-4388-8D9F-F149FC65EED5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34E77B-0924-48D6-AFBB-EBC6E90B16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25281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37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451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4427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946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449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757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916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1742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470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820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657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F763-AC99-489C-B36D-F6BA7E4BE26C}" type="datetimeFigureOut">
              <a:rPr lang="zh-CN" altLang="en-US" smtClean="0"/>
              <a:t>2018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894312-140B-4689-99C4-1BF5D73041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8350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/>
          <p:cNvGrpSpPr/>
          <p:nvPr/>
        </p:nvGrpSpPr>
        <p:grpSpPr>
          <a:xfrm>
            <a:off x="952647" y="962763"/>
            <a:ext cx="7636178" cy="2335380"/>
            <a:chOff x="952647" y="962763"/>
            <a:chExt cx="7636178" cy="2335380"/>
          </a:xfrm>
        </p:grpSpPr>
        <p:sp>
          <p:nvSpPr>
            <p:cNvPr id="4" name="文本框 3"/>
            <p:cNvSpPr txBox="1"/>
            <p:nvPr/>
          </p:nvSpPr>
          <p:spPr>
            <a:xfrm>
              <a:off x="952647" y="1507997"/>
              <a:ext cx="13220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iRanda</a:t>
              </a:r>
              <a:endParaRPr lang="zh-CN" altLang="en-US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437647" y="2450536"/>
              <a:ext cx="13220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iRWalk</a:t>
              </a:r>
              <a:endParaRPr lang="zh-CN" altLang="en-US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366493" y="3017744"/>
              <a:ext cx="13220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iRDB</a:t>
              </a:r>
              <a:endParaRPr lang="zh-CN" altLang="en-US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828541" y="1527829"/>
              <a:ext cx="13220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TargetScan</a:t>
              </a:r>
              <a:endParaRPr lang="zh-CN" altLang="en-US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4313957" y="1593145"/>
              <a:ext cx="4274868" cy="1271530"/>
              <a:chOff x="1696597" y="2978836"/>
              <a:chExt cx="4274868" cy="1271530"/>
            </a:xfrm>
            <a:noFill/>
          </p:grpSpPr>
          <p:sp>
            <p:nvSpPr>
              <p:cNvPr id="9" name="文本框 8"/>
              <p:cNvSpPr txBox="1"/>
              <p:nvPr/>
            </p:nvSpPr>
            <p:spPr>
              <a:xfrm>
                <a:off x="1696597" y="3205908"/>
                <a:ext cx="4274868" cy="2923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ema3A 3’UTR WT         5’-----------CAAGGAT------3’</a:t>
                </a:r>
                <a:endParaRPr lang="zh-CN" altLang="en-US" sz="13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1696597" y="3620885"/>
                <a:ext cx="4120309" cy="2923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hsa-miR-362-5p              3’-----AAGGUUCCUAA---5’</a:t>
                </a:r>
                <a:endParaRPr lang="zh-CN" altLang="en-US" sz="13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696597" y="3957978"/>
                <a:ext cx="4127000" cy="2923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ema3A 3’UTR MUT       5’ ----------GTTCCTA-------3’</a:t>
                </a:r>
                <a:endParaRPr lang="zh-CN" altLang="en-US" sz="13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4263992" y="2978836"/>
                <a:ext cx="1443210" cy="2923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binding site</a:t>
                </a:r>
                <a:endParaRPr lang="zh-CN" altLang="en-US" sz="13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4358222" y="3381628"/>
                <a:ext cx="1476261" cy="3693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| | | | | | | 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文本框 14"/>
            <p:cNvSpPr txBox="1"/>
            <p:nvPr/>
          </p:nvSpPr>
          <p:spPr>
            <a:xfrm>
              <a:off x="952647" y="962763"/>
              <a:ext cx="260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313957" y="962763"/>
              <a:ext cx="260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1082729" y="1584520"/>
              <a:ext cx="2436292" cy="1713623"/>
              <a:chOff x="2685264" y="4121135"/>
              <a:chExt cx="2436292" cy="1713623"/>
            </a:xfrm>
          </p:grpSpPr>
          <p:sp>
            <p:nvSpPr>
              <p:cNvPr id="19" name="椭圆 18"/>
              <p:cNvSpPr/>
              <p:nvPr/>
            </p:nvSpPr>
            <p:spPr>
              <a:xfrm>
                <a:off x="3456576" y="4121135"/>
                <a:ext cx="1127022" cy="1124356"/>
              </a:xfrm>
              <a:prstGeom prst="ellipse">
                <a:avLst/>
              </a:prstGeom>
              <a:solidFill>
                <a:srgbClr val="003A17">
                  <a:alpha val="56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" name="椭圆 19"/>
              <p:cNvSpPr/>
              <p:nvPr/>
            </p:nvSpPr>
            <p:spPr>
              <a:xfrm>
                <a:off x="4132672" y="4538745"/>
                <a:ext cx="988884" cy="957835"/>
              </a:xfrm>
              <a:prstGeom prst="ellipse">
                <a:avLst/>
              </a:prstGeom>
              <a:solidFill>
                <a:schemeClr val="accent4">
                  <a:lumMod val="75000"/>
                  <a:alpha val="6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" name="椭圆 20"/>
              <p:cNvSpPr/>
              <p:nvPr/>
            </p:nvSpPr>
            <p:spPr>
              <a:xfrm>
                <a:off x="3975482" y="4942364"/>
                <a:ext cx="598640" cy="586874"/>
              </a:xfrm>
              <a:prstGeom prst="ellipse">
                <a:avLst/>
              </a:prstGeom>
              <a:solidFill>
                <a:srgbClr val="0070C0">
                  <a:alpha val="5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椭圆 17"/>
              <p:cNvSpPr/>
              <p:nvPr/>
            </p:nvSpPr>
            <p:spPr>
              <a:xfrm>
                <a:off x="2685264" y="4253644"/>
                <a:ext cx="1595184" cy="1581114"/>
              </a:xfrm>
              <a:prstGeom prst="ellipse">
                <a:avLst/>
              </a:prstGeom>
              <a:solidFill>
                <a:srgbClr val="FF2929">
                  <a:alpha val="6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4030973" y="4920592"/>
                <a:ext cx="406609" cy="2772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zh-CN" alt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39132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</TotalTime>
  <Words>42</Words>
  <Application>Microsoft Office PowerPoint</Application>
  <PresentationFormat>信纸(8.5x11 英寸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o</dc:creator>
  <cp:lastModifiedBy>Luo</cp:lastModifiedBy>
  <cp:revision>228</cp:revision>
  <dcterms:created xsi:type="dcterms:W3CDTF">2016-10-17T06:59:00Z</dcterms:created>
  <dcterms:modified xsi:type="dcterms:W3CDTF">2018-06-14T02:42:33Z</dcterms:modified>
</cp:coreProperties>
</file>